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3354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vonne\Desktop\Dropbox\CheeeseBoard%20Work\Assays\Results\Pearce%20control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691062099093347"/>
          <c:y val="5.9676156910416236E-2"/>
          <c:w val="0.76364413823272093"/>
          <c:h val="0.69472257325386655"/>
        </c:manualLayout>
      </c:layout>
      <c:scatterChart>
        <c:scatterStyle val="smoothMarker"/>
        <c:varyColors val="0"/>
        <c:ser>
          <c:idx val="0"/>
          <c:order val="0"/>
          <c:tx>
            <c:v>L. lactis JM1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2,Sheet2!$K$2,Sheet2!$P$2,Sheet2!$U$2,Sheet2!$Z$2,Sheet2!$AE$2)</c:f>
                <c:numCache>
                  <c:formatCode>General</c:formatCode>
                  <c:ptCount val="6"/>
                  <c:pt idx="0">
                    <c:v>1.529838909408522E-2</c:v>
                  </c:pt>
                  <c:pt idx="1">
                    <c:v>3.5005972376638834E-2</c:v>
                  </c:pt>
                  <c:pt idx="2">
                    <c:v>9.5637479382978341E-2</c:v>
                  </c:pt>
                  <c:pt idx="3">
                    <c:v>2.7337663309758911E-2</c:v>
                  </c:pt>
                  <c:pt idx="4">
                    <c:v>1.386163842276983E-2</c:v>
                  </c:pt>
                  <c:pt idx="5">
                    <c:v>7.569217130367252E-2</c:v>
                  </c:pt>
                </c:numCache>
              </c:numRef>
            </c:plus>
            <c:minus>
              <c:numRef>
                <c:f>(Sheet2!$F$2,Sheet2!$K$2,Sheet2!$P$2,Sheet2!$U$2,Sheet2!$Z$2,Sheet2!$AE$2)</c:f>
                <c:numCache>
                  <c:formatCode>General</c:formatCode>
                  <c:ptCount val="6"/>
                  <c:pt idx="0">
                    <c:v>1.529838909408522E-2</c:v>
                  </c:pt>
                  <c:pt idx="1">
                    <c:v>3.5005972376638834E-2</c:v>
                  </c:pt>
                  <c:pt idx="2">
                    <c:v>9.5637479382978341E-2</c:v>
                  </c:pt>
                  <c:pt idx="3">
                    <c:v>2.7337663309758911E-2</c:v>
                  </c:pt>
                  <c:pt idx="4">
                    <c:v>1.386163842276983E-2</c:v>
                  </c:pt>
                  <c:pt idx="5">
                    <c:v>7.569217130367252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2,Sheet2!$J$2,Sheet2!$O$2,Sheet2!$T$2,Sheet2!$Y$2,Sheet2!$AD$2)</c:f>
              <c:numCache>
                <c:formatCode>General</c:formatCode>
                <c:ptCount val="6"/>
                <c:pt idx="0">
                  <c:v>6.5519943806255121</c:v>
                </c:pt>
                <c:pt idx="1">
                  <c:v>6.7839224424019458</c:v>
                </c:pt>
                <c:pt idx="2">
                  <c:v>7.5205658442179981</c:v>
                </c:pt>
                <c:pt idx="3">
                  <c:v>7.9251384270244856</c:v>
                </c:pt>
                <c:pt idx="4">
                  <c:v>8.0629874046870658</c:v>
                </c:pt>
                <c:pt idx="5">
                  <c:v>8.308917968396579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AB$2</c:f>
              <c:strCache>
                <c:ptCount val="1"/>
                <c:pt idx="0">
                  <c:v>LF100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2,Sheet3!$AL$2,Sheet3!$AQ$2,Sheet3!$AV$2,Sheet3!$BA$2,Sheet3!$BF$2)</c:f>
                <c:numCache>
                  <c:formatCode>General</c:formatCode>
                  <c:ptCount val="6"/>
                  <c:pt idx="0">
                    <c:v>1.529838909408522E-2</c:v>
                  </c:pt>
                  <c:pt idx="1">
                    <c:v>4.9481071938748775E-2</c:v>
                  </c:pt>
                  <c:pt idx="2">
                    <c:v>5.4873691859978549E-2</c:v>
                  </c:pt>
                  <c:pt idx="3">
                    <c:v>4.0643457573358716E-2</c:v>
                  </c:pt>
                  <c:pt idx="4">
                    <c:v>1.0535422526590288E-2</c:v>
                  </c:pt>
                  <c:pt idx="5">
                    <c:v>1.2578738182383805E-2</c:v>
                  </c:pt>
                </c:numCache>
              </c:numRef>
            </c:plus>
            <c:minus>
              <c:numRef>
                <c:f>(Sheet3!$AG$2,Sheet3!$AL$2,Sheet3!$AQ$2,Sheet3!$AV$2,Sheet3!$BA$2,Sheet3!$BF$2)</c:f>
                <c:numCache>
                  <c:formatCode>General</c:formatCode>
                  <c:ptCount val="6"/>
                  <c:pt idx="0">
                    <c:v>1.529838909408522E-2</c:v>
                  </c:pt>
                  <c:pt idx="1">
                    <c:v>4.9481071938748775E-2</c:v>
                  </c:pt>
                  <c:pt idx="2">
                    <c:v>5.4873691859978549E-2</c:v>
                  </c:pt>
                  <c:pt idx="3">
                    <c:v>4.0643457573358716E-2</c:v>
                  </c:pt>
                  <c:pt idx="4">
                    <c:v>1.0535422526590288E-2</c:v>
                  </c:pt>
                  <c:pt idx="5">
                    <c:v>1.2578738182383805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2,Sheet3!$AK$2,Sheet3!$AP$2,Sheet3!$AU$2,Sheet3!$AZ$2,Sheet3!$BE$2)</c:f>
              <c:numCache>
                <c:formatCode>General</c:formatCode>
                <c:ptCount val="6"/>
                <c:pt idx="0">
                  <c:v>6.5519943806255121</c:v>
                </c:pt>
                <c:pt idx="1">
                  <c:v>7.3460742127895733</c:v>
                </c:pt>
                <c:pt idx="2">
                  <c:v>7.6266556787917956</c:v>
                </c:pt>
                <c:pt idx="3">
                  <c:v>7.7251145431336097</c:v>
                </c:pt>
                <c:pt idx="4">
                  <c:v>7.5581811125381257</c:v>
                </c:pt>
                <c:pt idx="5">
                  <c:v>7.530444595389454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232640"/>
        <c:axId val="65486848"/>
      </c:scatterChart>
      <c:valAx>
        <c:axId val="50232640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s)</a:t>
                </a:r>
              </a:p>
            </c:rich>
          </c:tx>
          <c:layout>
            <c:manualLayout>
              <c:xMode val="edge"/>
              <c:yMode val="edge"/>
              <c:x val="0.38515938401257444"/>
              <c:y val="0.85822266726718599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65486848"/>
        <c:crosses val="autoZero"/>
        <c:crossBetween val="midCat"/>
      </c:valAx>
      <c:valAx>
        <c:axId val="65486848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392949438325076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50232640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52012248468942"/>
          <c:y val="5.9676156910416223E-2"/>
          <c:w val="0.76364413823272093"/>
          <c:h val="0.77246940194410796"/>
        </c:manualLayout>
      </c:layout>
      <c:scatterChart>
        <c:scatterStyle val="smoothMarker"/>
        <c:varyColors val="0"/>
        <c:ser>
          <c:idx val="0"/>
          <c:order val="0"/>
          <c:tx>
            <c:v>L. lactis UC17</c:v>
          </c:tx>
          <c:spPr>
            <a:ln w="12700">
              <a:solidFill>
                <a:srgbClr val="0070C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17,Sheet2!$K$17,Sheet2!$P$17,Sheet2!$U$17,Sheet2!$Z$17,Sheet2!$AE$17)</c:f>
                <c:numCache>
                  <c:formatCode>General</c:formatCode>
                  <c:ptCount val="6"/>
                  <c:pt idx="0">
                    <c:v>4.0810995655523397E-3</c:v>
                  </c:pt>
                  <c:pt idx="1">
                    <c:v>1.3691194668434318E-3</c:v>
                  </c:pt>
                  <c:pt idx="2">
                    <c:v>1.5556471799798922E-2</c:v>
                  </c:pt>
                  <c:pt idx="3">
                    <c:v>1.6745364479837842E-2</c:v>
                  </c:pt>
                  <c:pt idx="4">
                    <c:v>6.0873706536466739E-2</c:v>
                  </c:pt>
                  <c:pt idx="5">
                    <c:v>4.3803788263340276E-2</c:v>
                  </c:pt>
                </c:numCache>
              </c:numRef>
            </c:plus>
            <c:minus>
              <c:numRef>
                <c:f>(Sheet2!$F$17,Sheet2!$K$17,Sheet2!$P$17,Sheet2!$U$17,Sheet2!$Z$17,Sheet2!$AE$17)</c:f>
                <c:numCache>
                  <c:formatCode>General</c:formatCode>
                  <c:ptCount val="6"/>
                  <c:pt idx="0">
                    <c:v>4.0810995655523397E-3</c:v>
                  </c:pt>
                  <c:pt idx="1">
                    <c:v>1.3691194668434318E-3</c:v>
                  </c:pt>
                  <c:pt idx="2">
                    <c:v>1.5556471799798922E-2</c:v>
                  </c:pt>
                  <c:pt idx="3">
                    <c:v>1.6745364479837842E-2</c:v>
                  </c:pt>
                  <c:pt idx="4">
                    <c:v>6.0873706536466739E-2</c:v>
                  </c:pt>
                  <c:pt idx="5">
                    <c:v>4.3803788263340276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17,Sheet2!$J$17,Sheet2!$O$17,Sheet2!$T$17,Sheet2!$Y$17,Sheet2!$AD$17)</c:f>
              <c:numCache>
                <c:formatCode>General</c:formatCode>
                <c:ptCount val="6"/>
                <c:pt idx="0">
                  <c:v>7.1760720415897739</c:v>
                </c:pt>
                <c:pt idx="1">
                  <c:v>7.4132976060050995</c:v>
                </c:pt>
                <c:pt idx="2">
                  <c:v>7.8918136789817668</c:v>
                </c:pt>
                <c:pt idx="3">
                  <c:v>8.2056015165901961</c:v>
                </c:pt>
                <c:pt idx="4">
                  <c:v>8.5270889350912231</c:v>
                </c:pt>
                <c:pt idx="5">
                  <c:v>8.7025480157090627</c:v>
                </c:pt>
              </c:numCache>
            </c:numRef>
          </c:yVal>
          <c:smooth val="1"/>
        </c:ser>
        <c:ser>
          <c:idx val="1"/>
          <c:order val="1"/>
          <c:tx>
            <c:v>UC17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17,Sheet3!$AL$17,Sheet3!$AQ$17,Sheet3!$AV$17,Sheet3!$BA$17,Sheet3!$BF$17)</c:f>
                <c:numCache>
                  <c:formatCode>General</c:formatCode>
                  <c:ptCount val="6"/>
                  <c:pt idx="0">
                    <c:v>4.9346949121841101E-2</c:v>
                  </c:pt>
                  <c:pt idx="1">
                    <c:v>4.893034216088113E-2</c:v>
                  </c:pt>
                  <c:pt idx="2">
                    <c:v>0.50681450738013722</c:v>
                  </c:pt>
                  <c:pt idx="3">
                    <c:v>4.2776686414095412E-2</c:v>
                  </c:pt>
                  <c:pt idx="4">
                    <c:v>2.9104851742483184E-2</c:v>
                  </c:pt>
                  <c:pt idx="5">
                    <c:v>1.930807282514262E-2</c:v>
                  </c:pt>
                </c:numCache>
              </c:numRef>
            </c:plus>
            <c:minus>
              <c:numRef>
                <c:f>(Sheet3!$AG$17,Sheet3!$AL$17,Sheet3!$AQ$17,Sheet3!$AV$17,Sheet3!$BA$17,Sheet3!$BF$17)</c:f>
                <c:numCache>
                  <c:formatCode>General</c:formatCode>
                  <c:ptCount val="6"/>
                  <c:pt idx="0">
                    <c:v>4.9346949121841101E-2</c:v>
                  </c:pt>
                  <c:pt idx="1">
                    <c:v>4.893034216088113E-2</c:v>
                  </c:pt>
                  <c:pt idx="2">
                    <c:v>0.50681450738013722</c:v>
                  </c:pt>
                  <c:pt idx="3">
                    <c:v>4.2776686414095412E-2</c:v>
                  </c:pt>
                  <c:pt idx="4">
                    <c:v>2.9104851742483184E-2</c:v>
                  </c:pt>
                  <c:pt idx="5">
                    <c:v>1.930807282514262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17,Sheet3!$AK$17,Sheet3!$AP$17,Sheet3!$AU$17,Sheet3!$AZ$17,Sheet3!$BE$17)</c:f>
              <c:numCache>
                <c:formatCode>General</c:formatCode>
                <c:ptCount val="6"/>
                <c:pt idx="0">
                  <c:v>7.2604184896445032</c:v>
                </c:pt>
                <c:pt idx="1">
                  <c:v>7.6600768971303443</c:v>
                </c:pt>
                <c:pt idx="2">
                  <c:v>7.5016641726762714</c:v>
                </c:pt>
                <c:pt idx="3">
                  <c:v>8.1720483094422232</c:v>
                </c:pt>
                <c:pt idx="4">
                  <c:v>8.343429925628449</c:v>
                </c:pt>
                <c:pt idx="5">
                  <c:v>7.972694261547395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067904"/>
        <c:axId val="74068480"/>
      </c:scatterChart>
      <c:valAx>
        <c:axId val="74067904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4068480"/>
        <c:crosses val="autoZero"/>
        <c:crossBetween val="midCat"/>
      </c:valAx>
      <c:valAx>
        <c:axId val="74068480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Log</a:t>
                </a:r>
                <a:r>
                  <a:rPr lang="en-IE" sz="800" baseline="0"/>
                  <a:t> cfu/ml</a:t>
                </a:r>
                <a:endParaRPr lang="en-IE" sz="80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4067904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52012248468942"/>
          <c:y val="5.9676156910416223E-2"/>
          <c:w val="0.76364413823272093"/>
          <c:h val="0.77246940194410796"/>
        </c:manualLayout>
      </c:layout>
      <c:scatterChart>
        <c:scatterStyle val="smoothMarker"/>
        <c:varyColors val="0"/>
        <c:ser>
          <c:idx val="0"/>
          <c:order val="0"/>
          <c:tx>
            <c:v>L. lactis 275</c:v>
          </c:tx>
          <c:spPr>
            <a:ln w="12700">
              <a:solidFill>
                <a:srgbClr val="0070C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19,Sheet2!$K$19,Sheet2!$P$19,Sheet2!$U$19,Sheet2!$Z$19,Sheet2!$AE$19)</c:f>
                <c:numCache>
                  <c:formatCode>General</c:formatCode>
                  <c:ptCount val="6"/>
                  <c:pt idx="0">
                    <c:v>7.1437750876752845E-2</c:v>
                  </c:pt>
                  <c:pt idx="1">
                    <c:v>4.8695568139671193E-2</c:v>
                  </c:pt>
                  <c:pt idx="2">
                    <c:v>6.0544490471047159E-2</c:v>
                  </c:pt>
                  <c:pt idx="3">
                    <c:v>7.2744065460228366E-2</c:v>
                  </c:pt>
                  <c:pt idx="4">
                    <c:v>2.1719847473073973E-2</c:v>
                  </c:pt>
                  <c:pt idx="5">
                    <c:v>1.8963692268357122E-2</c:v>
                  </c:pt>
                </c:numCache>
              </c:numRef>
            </c:plus>
            <c:minus>
              <c:numRef>
                <c:f>(Sheet2!$F$19,Sheet2!$K$19,Sheet2!$P$19,Sheet2!$U$19,Sheet2!$Z$19,Sheet2!$AE$19)</c:f>
                <c:numCache>
                  <c:formatCode>General</c:formatCode>
                  <c:ptCount val="6"/>
                  <c:pt idx="0">
                    <c:v>7.1437750876752845E-2</c:v>
                  </c:pt>
                  <c:pt idx="1">
                    <c:v>4.8695568139671193E-2</c:v>
                  </c:pt>
                  <c:pt idx="2">
                    <c:v>6.0544490471047159E-2</c:v>
                  </c:pt>
                  <c:pt idx="3">
                    <c:v>7.2744065460228366E-2</c:v>
                  </c:pt>
                  <c:pt idx="4">
                    <c:v>2.1719847473073973E-2</c:v>
                  </c:pt>
                  <c:pt idx="5">
                    <c:v>1.8963692268357122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19,Sheet2!$J$19,Sheet2!$O$19,Sheet2!$T$19,Sheet2!$Y$19,Sheet2!$AD$19)</c:f>
              <c:numCache>
                <c:formatCode>General</c:formatCode>
                <c:ptCount val="6"/>
                <c:pt idx="0">
                  <c:v>6.7074631871104309</c:v>
                </c:pt>
                <c:pt idx="1">
                  <c:v>6.6407354258130056</c:v>
                </c:pt>
                <c:pt idx="2">
                  <c:v>7.1230322294910779</c:v>
                </c:pt>
                <c:pt idx="3">
                  <c:v>7.4035286749683857</c:v>
                </c:pt>
                <c:pt idx="4">
                  <c:v>8.8934088998320391</c:v>
                </c:pt>
                <c:pt idx="5">
                  <c:v>8.9711752131519944</c:v>
                </c:pt>
              </c:numCache>
            </c:numRef>
          </c:yVal>
          <c:smooth val="1"/>
        </c:ser>
        <c:ser>
          <c:idx val="1"/>
          <c:order val="1"/>
          <c:tx>
            <c:v>275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19,Sheet3!$AL$19,Sheet3!$AQ$19,Sheet3!$AV$19,Sheet3!$BA$19,Sheet3!$BF$19)</c:f>
                <c:numCache>
                  <c:formatCode>General</c:formatCode>
                  <c:ptCount val="6"/>
                  <c:pt idx="0">
                    <c:v>9.4636132554866095E-2</c:v>
                  </c:pt>
                  <c:pt idx="1">
                    <c:v>5.1049677832683008E-2</c:v>
                  </c:pt>
                  <c:pt idx="2">
                    <c:v>6.0478417668254373E-3</c:v>
                  </c:pt>
                  <c:pt idx="3">
                    <c:v>8.2125304451668102E-2</c:v>
                  </c:pt>
                  <c:pt idx="4">
                    <c:v>1.5172005241506486E-2</c:v>
                  </c:pt>
                  <c:pt idx="5">
                    <c:v>2.6237958415869688E-2</c:v>
                  </c:pt>
                </c:numCache>
              </c:numRef>
            </c:plus>
            <c:minus>
              <c:numRef>
                <c:f>(Sheet3!$AG$19,Sheet3!$AL$19,Sheet3!$AQ$19,Sheet3!$AV$19,Sheet3!$BA$19,Sheet3!$BF$19)</c:f>
                <c:numCache>
                  <c:formatCode>General</c:formatCode>
                  <c:ptCount val="6"/>
                  <c:pt idx="0">
                    <c:v>9.4636132554866095E-2</c:v>
                  </c:pt>
                  <c:pt idx="1">
                    <c:v>5.1049677832683008E-2</c:v>
                  </c:pt>
                  <c:pt idx="2">
                    <c:v>6.0478417668254373E-3</c:v>
                  </c:pt>
                  <c:pt idx="3">
                    <c:v>8.2125304451668102E-2</c:v>
                  </c:pt>
                  <c:pt idx="4">
                    <c:v>1.5172005241506486E-2</c:v>
                  </c:pt>
                  <c:pt idx="5">
                    <c:v>2.6237958415869688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19,Sheet3!$AK$19,Sheet3!$AP$19,Sheet3!$AU$19,Sheet3!$AZ$19,Sheet3!$BE$19)</c:f>
              <c:numCache>
                <c:formatCode>General</c:formatCode>
                <c:ptCount val="6"/>
                <c:pt idx="0">
                  <c:v>6.4525496776394888</c:v>
                </c:pt>
                <c:pt idx="1">
                  <c:v>6.5410830967993006</c:v>
                </c:pt>
                <c:pt idx="2">
                  <c:v>6.9509713570387248</c:v>
                </c:pt>
                <c:pt idx="3">
                  <c:v>7.3280106600903929</c:v>
                </c:pt>
                <c:pt idx="4">
                  <c:v>7.7267315714252662</c:v>
                </c:pt>
                <c:pt idx="5">
                  <c:v>7.829579404091621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070208"/>
        <c:axId val="74070784"/>
      </c:scatterChart>
      <c:valAx>
        <c:axId val="74070208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4070784"/>
        <c:crosses val="autoZero"/>
        <c:crossBetween val="midCat"/>
      </c:valAx>
      <c:valAx>
        <c:axId val="74070784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Log</a:t>
                </a:r>
                <a:r>
                  <a:rPr lang="en-IE" sz="800" baseline="0"/>
                  <a:t> cfu/ml</a:t>
                </a:r>
                <a:endParaRPr lang="en-IE" sz="80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4070208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52012248468942"/>
          <c:y val="5.9676156910416223E-2"/>
          <c:w val="0.76364413823272093"/>
          <c:h val="0.75025602231832478"/>
        </c:manualLayout>
      </c:layout>
      <c:scatterChart>
        <c:scatterStyle val="smoothMarker"/>
        <c:varyColors val="0"/>
        <c:ser>
          <c:idx val="0"/>
          <c:order val="0"/>
          <c:tx>
            <c:v>L. lactis 184</c:v>
          </c:tx>
          <c:spPr>
            <a:ln w="12700">
              <a:solidFill>
                <a:srgbClr val="0070C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20,Sheet2!$K$20,Sheet2!$P$20,Sheet2!$U$20,Sheet2!$Z$20,Sheet2!$AE$20)</c:f>
                <c:numCache>
                  <c:formatCode>General</c:formatCode>
                  <c:ptCount val="6"/>
                  <c:pt idx="0">
                    <c:v>4.7139759768008591E-2</c:v>
                  </c:pt>
                  <c:pt idx="1">
                    <c:v>6.7498960212298523E-2</c:v>
                  </c:pt>
                  <c:pt idx="2">
                    <c:v>6.7498960212298523E-2</c:v>
                  </c:pt>
                  <c:pt idx="3">
                    <c:v>7.5792504918900022E-2</c:v>
                  </c:pt>
                  <c:pt idx="4">
                    <c:v>3.5541280256773763E-2</c:v>
                  </c:pt>
                  <c:pt idx="5">
                    <c:v>1.5192190057232487E-2</c:v>
                  </c:pt>
                </c:numCache>
              </c:numRef>
            </c:plus>
            <c:minus>
              <c:numRef>
                <c:f>(Sheet2!$F$20,Sheet2!$K$20,Sheet2!$P$20,Sheet2!$U$20,Sheet2!$Z$20,Sheet2!$AE$20)</c:f>
                <c:numCache>
                  <c:formatCode>General</c:formatCode>
                  <c:ptCount val="6"/>
                  <c:pt idx="0">
                    <c:v>4.7139759768008591E-2</c:v>
                  </c:pt>
                  <c:pt idx="1">
                    <c:v>6.7498960212298523E-2</c:v>
                  </c:pt>
                  <c:pt idx="2">
                    <c:v>6.7498960212298523E-2</c:v>
                  </c:pt>
                  <c:pt idx="3">
                    <c:v>7.5792504918900022E-2</c:v>
                  </c:pt>
                  <c:pt idx="4">
                    <c:v>3.5541280256773763E-2</c:v>
                  </c:pt>
                  <c:pt idx="5">
                    <c:v>1.519219005723248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20,Sheet2!$J$20,Sheet2!$O$20,Sheet2!$T$20,Sheet2!$Y$20,Sheet2!$AD$20)</c:f>
              <c:numCache>
                <c:formatCode>General</c:formatCode>
                <c:ptCount val="6"/>
                <c:pt idx="0">
                  <c:v>6.2969602975440369</c:v>
                </c:pt>
                <c:pt idx="1">
                  <c:v>7.6446879798231828</c:v>
                </c:pt>
                <c:pt idx="2">
                  <c:v>7.6446879798231828</c:v>
                </c:pt>
                <c:pt idx="3">
                  <c:v>8.0759567525491036</c:v>
                </c:pt>
                <c:pt idx="4">
                  <c:v>8.4945290989896307</c:v>
                </c:pt>
                <c:pt idx="5">
                  <c:v>8.9835093092084737</c:v>
                </c:pt>
              </c:numCache>
            </c:numRef>
          </c:yVal>
          <c:smooth val="1"/>
        </c:ser>
        <c:ser>
          <c:idx val="1"/>
          <c:order val="1"/>
          <c:tx>
            <c:v>184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20,Sheet3!$AL$20,Sheet3!$AQ$20,Sheet3!$AV$20,Sheet3!$BA$20,Sheet3!$BF$20)</c:f>
                <c:numCache>
                  <c:formatCode>General</c:formatCode>
                  <c:ptCount val="6"/>
                  <c:pt idx="0">
                    <c:v>4.7139759768008591E-2</c:v>
                  </c:pt>
                  <c:pt idx="1">
                    <c:v>1.5839075318092317E-2</c:v>
                  </c:pt>
                  <c:pt idx="2">
                    <c:v>2.6171119330648123E-2</c:v>
                  </c:pt>
                  <c:pt idx="3">
                    <c:v>4.8314297007902136E-2</c:v>
                  </c:pt>
                  <c:pt idx="4">
                    <c:v>8.2992454541515603E-2</c:v>
                  </c:pt>
                  <c:pt idx="5">
                    <c:v>6.7240965612832396E-2</c:v>
                  </c:pt>
                </c:numCache>
              </c:numRef>
            </c:plus>
            <c:minus>
              <c:numRef>
                <c:f>(Sheet3!$AG$20,Sheet3!$AL$20,Sheet3!$AQ$20,Sheet3!$AV$20,Sheet3!$BA$20,Sheet3!$BF$20)</c:f>
                <c:numCache>
                  <c:formatCode>General</c:formatCode>
                  <c:ptCount val="6"/>
                  <c:pt idx="0">
                    <c:v>4.7139759768008591E-2</c:v>
                  </c:pt>
                  <c:pt idx="1">
                    <c:v>1.5839075318092317E-2</c:v>
                  </c:pt>
                  <c:pt idx="2">
                    <c:v>2.6171119330648123E-2</c:v>
                  </c:pt>
                  <c:pt idx="3">
                    <c:v>4.8314297007902136E-2</c:v>
                  </c:pt>
                  <c:pt idx="4">
                    <c:v>8.2992454541515603E-2</c:v>
                  </c:pt>
                  <c:pt idx="5">
                    <c:v>6.7240965612832396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20,Sheet3!$AK$20,Sheet3!$AP$20,Sheet3!$AU$20,Sheet3!$AZ$20,Sheet3!$BE$20)</c:f>
              <c:numCache>
                <c:formatCode>General</c:formatCode>
                <c:ptCount val="6"/>
                <c:pt idx="0">
                  <c:v>6.2969602975440369</c:v>
                </c:pt>
                <c:pt idx="1">
                  <c:v>7.1767680745880993</c:v>
                </c:pt>
                <c:pt idx="2">
                  <c:v>7.3609284567721502</c:v>
                </c:pt>
                <c:pt idx="3">
                  <c:v>7.6992199420735288</c:v>
                </c:pt>
                <c:pt idx="4">
                  <c:v>7.6372025449874315</c:v>
                </c:pt>
                <c:pt idx="5">
                  <c:v>7.442512370616331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105408"/>
        <c:axId val="74105984"/>
      </c:scatterChart>
      <c:valAx>
        <c:axId val="74105408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4105984"/>
        <c:crosses val="autoZero"/>
        <c:crossBetween val="midCat"/>
      </c:valAx>
      <c:valAx>
        <c:axId val="74105984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Log</a:t>
                </a:r>
                <a:r>
                  <a:rPr lang="en-IE" sz="800" baseline="0"/>
                  <a:t> cfu/ml</a:t>
                </a:r>
                <a:endParaRPr lang="en-IE" sz="80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4105408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88468357782912"/>
          <c:y val="6.2891849701125102E-2"/>
          <c:w val="0.76364413823272093"/>
          <c:h val="0.72804264269254149"/>
        </c:manualLayout>
      </c:layout>
      <c:scatterChart>
        <c:scatterStyle val="smoothMarker"/>
        <c:varyColors val="0"/>
        <c:ser>
          <c:idx val="0"/>
          <c:order val="0"/>
          <c:tx>
            <c:v>L. lactis JM4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3,Sheet2!$K$3,Sheet2!$P$3,Sheet2!$U$3,Sheet2!$Z$3,Sheet2!$AE$3)</c:f>
                <c:numCache>
                  <c:formatCode>General</c:formatCode>
                  <c:ptCount val="6"/>
                  <c:pt idx="0">
                    <c:v>5.6849258965552998E-2</c:v>
                  </c:pt>
                  <c:pt idx="1">
                    <c:v>9.4904560880869626E-2</c:v>
                  </c:pt>
                  <c:pt idx="2">
                    <c:v>5.8623915399546027E-2</c:v>
                  </c:pt>
                  <c:pt idx="3">
                    <c:v>4.3724680017566062E-2</c:v>
                  </c:pt>
                  <c:pt idx="4">
                    <c:v>2.1327161417434837E-2</c:v>
                  </c:pt>
                  <c:pt idx="5">
                    <c:v>0.10266338138223942</c:v>
                  </c:pt>
                </c:numCache>
              </c:numRef>
            </c:plus>
            <c:minus>
              <c:numRef>
                <c:f>(Sheet2!$F$3,Sheet2!$K$3,Sheet2!$P$3,Sheet2!$U$3,Sheet2!$Z$3,Sheet2!$AE$3)</c:f>
                <c:numCache>
                  <c:formatCode>General</c:formatCode>
                  <c:ptCount val="6"/>
                  <c:pt idx="0">
                    <c:v>5.6849258965552998E-2</c:v>
                  </c:pt>
                  <c:pt idx="1">
                    <c:v>9.4904560880869626E-2</c:v>
                  </c:pt>
                  <c:pt idx="2">
                    <c:v>5.8623915399546027E-2</c:v>
                  </c:pt>
                  <c:pt idx="3">
                    <c:v>4.3724680017566062E-2</c:v>
                  </c:pt>
                  <c:pt idx="4">
                    <c:v>2.1327161417434837E-2</c:v>
                  </c:pt>
                  <c:pt idx="5">
                    <c:v>0.1026633813822394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3,Sheet2!$J$3,Sheet2!$N$3,Sheet2!$N$3,Sheet2!$O$3,Sheet2!$T$3,Sheet2!$Y$3,Sheet2!$AD$3)</c:f>
              <c:numCache>
                <c:formatCode>General</c:formatCode>
                <c:ptCount val="8"/>
                <c:pt idx="0">
                  <c:v>5.8267533226686892</c:v>
                </c:pt>
                <c:pt idx="1">
                  <c:v>6.6653724920457629</c:v>
                </c:pt>
                <c:pt idx="2">
                  <c:v>6.826074802700826</c:v>
                </c:pt>
                <c:pt idx="3">
                  <c:v>6.826074802700826</c:v>
                </c:pt>
                <c:pt idx="4">
                  <c:v>6.9082118158801791</c:v>
                </c:pt>
                <c:pt idx="5">
                  <c:v>7.3531373124795527</c:v>
                </c:pt>
                <c:pt idx="6">
                  <c:v>7.4088494512804708</c:v>
                </c:pt>
                <c:pt idx="7">
                  <c:v>7.8330401603750888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AB$3</c:f>
              <c:strCache>
                <c:ptCount val="1"/>
                <c:pt idx="0">
                  <c:v>LF101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3,Sheet3!$AL$3,Sheet3!$AQ$3,Sheet3!$AV$3,Sheet3!$BA$3,Sheet3!$BF$3)</c:f>
                <c:numCache>
                  <c:formatCode>General</c:formatCode>
                  <c:ptCount val="6"/>
                  <c:pt idx="0">
                    <c:v>5.6849258965552998E-2</c:v>
                  </c:pt>
                  <c:pt idx="1">
                    <c:v>7.5382607988802808E-2</c:v>
                  </c:pt>
                  <c:pt idx="2">
                    <c:v>2.7337665974755381E-2</c:v>
                  </c:pt>
                  <c:pt idx="3">
                    <c:v>0.15278310535245843</c:v>
                  </c:pt>
                  <c:pt idx="4">
                    <c:v>1.7299849210726737E-2</c:v>
                  </c:pt>
                  <c:pt idx="5">
                    <c:v>2.367728747735065E-2</c:v>
                  </c:pt>
                </c:numCache>
              </c:numRef>
            </c:plus>
            <c:minus>
              <c:numRef>
                <c:f>(Sheet3!$AG$3,Sheet3!$AL$3,Sheet3!$AQ$3,Sheet3!$AV$3,Sheet3!$BA$3,Sheet3!$BF$3)</c:f>
                <c:numCache>
                  <c:formatCode>General</c:formatCode>
                  <c:ptCount val="6"/>
                  <c:pt idx="0">
                    <c:v>5.6849258965552998E-2</c:v>
                  </c:pt>
                  <c:pt idx="1">
                    <c:v>7.5382607988802808E-2</c:v>
                  </c:pt>
                  <c:pt idx="2">
                    <c:v>2.7337665974755381E-2</c:v>
                  </c:pt>
                  <c:pt idx="3">
                    <c:v>0.15278310535245843</c:v>
                  </c:pt>
                  <c:pt idx="4">
                    <c:v>1.7299849210726737E-2</c:v>
                  </c:pt>
                  <c:pt idx="5">
                    <c:v>2.367728747735065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3,Sheet3!$AK$3,Sheet3!$AP$3,Sheet3!$AU$3,Sheet3!$AZ$3,Sheet3!$BE$3)</c:f>
              <c:numCache>
                <c:formatCode>General</c:formatCode>
                <c:ptCount val="6"/>
                <c:pt idx="0">
                  <c:v>5.8267533226686892</c:v>
                </c:pt>
                <c:pt idx="1">
                  <c:v>6.7925926055212402</c:v>
                </c:pt>
                <c:pt idx="2">
                  <c:v>7.184789333663363</c:v>
                </c:pt>
                <c:pt idx="3">
                  <c:v>7.2434864200152562</c:v>
                </c:pt>
                <c:pt idx="4">
                  <c:v>7.0180766366211325</c:v>
                </c:pt>
                <c:pt idx="5">
                  <c:v>6.977084802138804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488576"/>
        <c:axId val="65489152"/>
      </c:scatterChart>
      <c:valAx>
        <c:axId val="65488576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65489152"/>
        <c:crosses val="autoZero"/>
        <c:crossBetween val="midCat"/>
      </c:valAx>
      <c:valAx>
        <c:axId val="65489152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105601007472965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65488576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88468357782912"/>
          <c:y val="6.2891849701125102E-2"/>
          <c:w val="0.76364413823272093"/>
          <c:h val="0.72550122217315072"/>
        </c:manualLayout>
      </c:layout>
      <c:scatterChart>
        <c:scatterStyle val="smoothMarker"/>
        <c:varyColors val="0"/>
        <c:ser>
          <c:idx val="0"/>
          <c:order val="0"/>
          <c:tx>
            <c:v>L. lactis JM3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4,Sheet2!$K$4,Sheet2!$P$4,Sheet2!$U$4,Sheet2!$Z$4,Sheet2!$AE$4)</c:f>
                <c:numCache>
                  <c:formatCode>General</c:formatCode>
                  <c:ptCount val="6"/>
                  <c:pt idx="0">
                    <c:v>3.3066659085659533E-2</c:v>
                  </c:pt>
                  <c:pt idx="1">
                    <c:v>2.1345239720682432E-2</c:v>
                  </c:pt>
                  <c:pt idx="2">
                    <c:v>5.6185011415678061E-2</c:v>
                  </c:pt>
                  <c:pt idx="3">
                    <c:v>4.574456504040094E-2</c:v>
                  </c:pt>
                  <c:pt idx="4">
                    <c:v>1.938055734916445E-2</c:v>
                  </c:pt>
                  <c:pt idx="5">
                    <c:v>5.8896685259072545E-2</c:v>
                  </c:pt>
                </c:numCache>
              </c:numRef>
            </c:plus>
            <c:minus>
              <c:numRef>
                <c:f>(Sheet2!$F$4,Sheet2!$K$4,Sheet2!$P$4,Sheet2!$U$4,Sheet2!$Z$4,Sheet2!$AE$4)</c:f>
                <c:numCache>
                  <c:formatCode>General</c:formatCode>
                  <c:ptCount val="6"/>
                  <c:pt idx="0">
                    <c:v>3.3066659085659533E-2</c:v>
                  </c:pt>
                  <c:pt idx="1">
                    <c:v>2.1345239720682432E-2</c:v>
                  </c:pt>
                  <c:pt idx="2">
                    <c:v>5.6185011415678061E-2</c:v>
                  </c:pt>
                  <c:pt idx="3">
                    <c:v>4.574456504040094E-2</c:v>
                  </c:pt>
                  <c:pt idx="4">
                    <c:v>1.938055734916445E-2</c:v>
                  </c:pt>
                  <c:pt idx="5">
                    <c:v>5.8896685259072545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4,Sheet2!$J$4,Sheet2!$O$4,Sheet2!$T$4,Sheet2!$Y$4,Sheet2!$AD$4)</c:f>
              <c:numCache>
                <c:formatCode>General</c:formatCode>
                <c:ptCount val="6"/>
                <c:pt idx="0">
                  <c:v>6.5216342241764025</c:v>
                </c:pt>
                <c:pt idx="1">
                  <c:v>6.7678687968782141</c:v>
                </c:pt>
                <c:pt idx="2">
                  <c:v>7.3184824035258984</c:v>
                </c:pt>
                <c:pt idx="3">
                  <c:v>7.5886654001849818</c:v>
                </c:pt>
                <c:pt idx="4">
                  <c:v>7.8467330973645311</c:v>
                </c:pt>
                <c:pt idx="5">
                  <c:v>8.296918750639406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AB$4</c:f>
              <c:strCache>
                <c:ptCount val="1"/>
                <c:pt idx="0">
                  <c:v>LF102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4,Sheet3!$AL$4,Sheet3!$AQ$4,Sheet3!$AV$4,Sheet3!$BA$4,Sheet3!$BF$4)</c:f>
                <c:numCache>
                  <c:formatCode>General</c:formatCode>
                  <c:ptCount val="6"/>
                  <c:pt idx="0">
                    <c:v>0.1039295162174424</c:v>
                  </c:pt>
                  <c:pt idx="1">
                    <c:v>3.3791183465995404E-2</c:v>
                  </c:pt>
                  <c:pt idx="2">
                    <c:v>3.17466229136181E-2</c:v>
                  </c:pt>
                  <c:pt idx="3">
                    <c:v>4.9372717721767372E-2</c:v>
                  </c:pt>
                  <c:pt idx="4">
                    <c:v>3.520552936520549E-2</c:v>
                  </c:pt>
                  <c:pt idx="5">
                    <c:v>4.2884528844780327E-2</c:v>
                  </c:pt>
                </c:numCache>
              </c:numRef>
            </c:plus>
            <c:minus>
              <c:numRef>
                <c:f>(Sheet3!$AG$4,Sheet3!$AL$4,Sheet3!$AQ$4,Sheet3!$AV$4,Sheet3!$BA$4,Sheet3!$BF$4)</c:f>
                <c:numCache>
                  <c:formatCode>General</c:formatCode>
                  <c:ptCount val="6"/>
                  <c:pt idx="0">
                    <c:v>0.1039295162174424</c:v>
                  </c:pt>
                  <c:pt idx="1">
                    <c:v>3.3791183465995404E-2</c:v>
                  </c:pt>
                  <c:pt idx="2">
                    <c:v>3.17466229136181E-2</c:v>
                  </c:pt>
                  <c:pt idx="3">
                    <c:v>4.9372717721767372E-2</c:v>
                  </c:pt>
                  <c:pt idx="4">
                    <c:v>3.520552936520549E-2</c:v>
                  </c:pt>
                  <c:pt idx="5">
                    <c:v>4.288452884478032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4,Sheet3!$AK$4,Sheet3!$AP$4,Sheet3!$AU$4,Sheet3!$AZ$4,Sheet3!$BE$4)</c:f>
              <c:numCache>
                <c:formatCode>General</c:formatCode>
                <c:ptCount val="6"/>
                <c:pt idx="0">
                  <c:v>6.5012635610190612</c:v>
                </c:pt>
                <c:pt idx="1">
                  <c:v>6.9107536794844551</c:v>
                </c:pt>
                <c:pt idx="2">
                  <c:v>7.0415274896811555</c:v>
                </c:pt>
                <c:pt idx="3">
                  <c:v>7.0763044686648966</c:v>
                </c:pt>
                <c:pt idx="4">
                  <c:v>7.0920090974664092</c:v>
                </c:pt>
                <c:pt idx="5">
                  <c:v>7.049652613790378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490880"/>
        <c:axId val="65491456"/>
      </c:scatterChart>
      <c:valAx>
        <c:axId val="65490880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65491456"/>
        <c:crosses val="autoZero"/>
        <c:crossBetween val="midCat"/>
      </c:valAx>
      <c:valAx>
        <c:axId val="65491456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65490880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719043149168401"/>
          <c:y val="4.0678470075341838E-2"/>
          <c:w val="0.76364413823272093"/>
          <c:h val="0.72804264269254149"/>
        </c:manualLayout>
      </c:layout>
      <c:scatterChart>
        <c:scatterStyle val="smoothMarker"/>
        <c:varyColors val="0"/>
        <c:ser>
          <c:idx val="0"/>
          <c:order val="0"/>
          <c:tx>
            <c:v>L. lactis JM2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2,Sheet2!$K$2,Sheet2!$P$2,Sheet2!$U$2,Sheet2!$Z$2,Sheet2!$AE$2)</c:f>
                <c:numCache>
                  <c:formatCode>General</c:formatCode>
                  <c:ptCount val="6"/>
                  <c:pt idx="0">
                    <c:v>1.529838909408522E-2</c:v>
                  </c:pt>
                  <c:pt idx="1">
                    <c:v>3.5005972376638834E-2</c:v>
                  </c:pt>
                  <c:pt idx="2">
                    <c:v>9.5637479382978341E-2</c:v>
                  </c:pt>
                  <c:pt idx="3">
                    <c:v>2.7337663309758911E-2</c:v>
                  </c:pt>
                  <c:pt idx="4">
                    <c:v>1.386163842276983E-2</c:v>
                  </c:pt>
                  <c:pt idx="5">
                    <c:v>7.569217130367252E-2</c:v>
                  </c:pt>
                </c:numCache>
              </c:numRef>
            </c:plus>
            <c:minus>
              <c:numRef>
                <c:f>(Sheet2!$F$2,Sheet2!$K$2,Sheet2!$P$2,Sheet2!$U$2,Sheet2!$Z$2,Sheet2!$AE$2)</c:f>
                <c:numCache>
                  <c:formatCode>General</c:formatCode>
                  <c:ptCount val="6"/>
                  <c:pt idx="0">
                    <c:v>1.529838909408522E-2</c:v>
                  </c:pt>
                  <c:pt idx="1">
                    <c:v>3.5005972376638834E-2</c:v>
                  </c:pt>
                  <c:pt idx="2">
                    <c:v>9.5637479382978341E-2</c:v>
                  </c:pt>
                  <c:pt idx="3">
                    <c:v>2.7337663309758911E-2</c:v>
                  </c:pt>
                  <c:pt idx="4">
                    <c:v>1.386163842276983E-2</c:v>
                  </c:pt>
                  <c:pt idx="5">
                    <c:v>7.569217130367252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5,Sheet2!$J$5,Sheet2!$O$5,Sheet2!$T$5,Sheet2!$Y$5,Sheet2!$AD$5)</c:f>
              <c:numCache>
                <c:formatCode>General</c:formatCode>
                <c:ptCount val="6"/>
                <c:pt idx="0">
                  <c:v>6.869048693908069</c:v>
                </c:pt>
                <c:pt idx="1">
                  <c:v>7.4206818529789444</c:v>
                </c:pt>
                <c:pt idx="2">
                  <c:v>7.4887086234727329</c:v>
                </c:pt>
                <c:pt idx="3">
                  <c:v>7.6931207214643491</c:v>
                </c:pt>
                <c:pt idx="4">
                  <c:v>8.0920960172092204</c:v>
                </c:pt>
                <c:pt idx="5">
                  <c:v>8.465748193670128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AB$5</c:f>
              <c:strCache>
                <c:ptCount val="1"/>
                <c:pt idx="0">
                  <c:v>LF106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5,Sheet3!$AL$5,Sheet3!$AQ$5,Sheet3!$AV$5,Sheet3!$BA$5,Sheet3!$BF$5)</c:f>
                <c:numCache>
                  <c:formatCode>General</c:formatCode>
                  <c:ptCount val="6"/>
                  <c:pt idx="0">
                    <c:v>4.2949290188624853E-2</c:v>
                  </c:pt>
                  <c:pt idx="1">
                    <c:v>0.47980795007326482</c:v>
                  </c:pt>
                  <c:pt idx="2">
                    <c:v>3.5257994060878407E-2</c:v>
                  </c:pt>
                  <c:pt idx="3">
                    <c:v>6.9406098260482363E-3</c:v>
                  </c:pt>
                  <c:pt idx="4">
                    <c:v>2.0657513929432544E-2</c:v>
                  </c:pt>
                  <c:pt idx="5">
                    <c:v>3.1193392971706597E-2</c:v>
                  </c:pt>
                </c:numCache>
              </c:numRef>
            </c:plus>
            <c:minus>
              <c:numRef>
                <c:f>(Sheet3!$AG$5,Sheet3!$AL$5,Sheet3!$AQ$5,Sheet3!$AV$5,Sheet3!$BA$5,Sheet3!$BF$5)</c:f>
                <c:numCache>
                  <c:formatCode>General</c:formatCode>
                  <c:ptCount val="6"/>
                  <c:pt idx="0">
                    <c:v>4.2949290188624853E-2</c:v>
                  </c:pt>
                  <c:pt idx="1">
                    <c:v>0.47980795007326482</c:v>
                  </c:pt>
                  <c:pt idx="2">
                    <c:v>3.5257994060878407E-2</c:v>
                  </c:pt>
                  <c:pt idx="3">
                    <c:v>6.9406098260482363E-3</c:v>
                  </c:pt>
                  <c:pt idx="4">
                    <c:v>2.0657513929432544E-2</c:v>
                  </c:pt>
                  <c:pt idx="5">
                    <c:v>3.119339297170659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5,Sheet3!$AK$5,Sheet3!$AP$5,Sheet3!$AU$5,Sheet3!$AZ$5,Sheet3!$BE$5)</c:f>
              <c:numCache>
                <c:formatCode>General</c:formatCode>
                <c:ptCount val="6"/>
                <c:pt idx="0">
                  <c:v>6.869048693908069</c:v>
                </c:pt>
                <c:pt idx="1">
                  <c:v>7.7367193125510809</c:v>
                </c:pt>
                <c:pt idx="2">
                  <c:v>7.7862763938977748</c:v>
                </c:pt>
                <c:pt idx="3">
                  <c:v>7.4673057501725255</c:v>
                </c:pt>
                <c:pt idx="4">
                  <c:v>7.4388418156324745</c:v>
                </c:pt>
                <c:pt idx="5">
                  <c:v>7.254139903365135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493184"/>
        <c:axId val="65493760"/>
      </c:scatterChart>
      <c:valAx>
        <c:axId val="65493184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65493760"/>
        <c:crosses val="autoZero"/>
        <c:crossBetween val="midCat"/>
      </c:valAx>
      <c:valAx>
        <c:axId val="65493760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65493184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89497205173795"/>
          <c:y val="6.80580594908686E-2"/>
          <c:w val="0.76364413823272093"/>
          <c:h val="0.70831683150927804"/>
        </c:manualLayout>
      </c:layout>
      <c:scatterChart>
        <c:scatterStyle val="smoothMarker"/>
        <c:varyColors val="0"/>
        <c:ser>
          <c:idx val="0"/>
          <c:order val="0"/>
          <c:tx>
            <c:v>L. lactis 229</c:v>
          </c:tx>
          <c:spPr>
            <a:ln w="12700">
              <a:solidFill>
                <a:srgbClr val="0070C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8,Sheet2!$K$8,Sheet2!$P$8,Sheet2!$U$8,Sheet2!$Z$8,Sheet2!$AE$8)</c:f>
                <c:numCache>
                  <c:formatCode>General</c:formatCode>
                  <c:ptCount val="6"/>
                  <c:pt idx="0">
                    <c:v>2.1387351793530192E-2</c:v>
                  </c:pt>
                  <c:pt idx="1">
                    <c:v>2.504238315886087E-2</c:v>
                  </c:pt>
                  <c:pt idx="2">
                    <c:v>2.0408065526886617E-2</c:v>
                  </c:pt>
                  <c:pt idx="3">
                    <c:v>5.6610051059953294E-2</c:v>
                  </c:pt>
                  <c:pt idx="4">
                    <c:v>5.6308801338060079E-2</c:v>
                  </c:pt>
                  <c:pt idx="5">
                    <c:v>3.0991879561905671E-2</c:v>
                  </c:pt>
                </c:numCache>
              </c:numRef>
            </c:plus>
            <c:minus>
              <c:numRef>
                <c:f>(Sheet2!$F$8,Sheet2!$K$8,Sheet2!$P$8,Sheet2!$U$8,Sheet2!$Z$8,Sheet2!$AE$8)</c:f>
                <c:numCache>
                  <c:formatCode>General</c:formatCode>
                  <c:ptCount val="6"/>
                  <c:pt idx="0">
                    <c:v>2.1387351793530192E-2</c:v>
                  </c:pt>
                  <c:pt idx="1">
                    <c:v>2.504238315886087E-2</c:v>
                  </c:pt>
                  <c:pt idx="2">
                    <c:v>2.0408065526886617E-2</c:v>
                  </c:pt>
                  <c:pt idx="3">
                    <c:v>5.6610051059953294E-2</c:v>
                  </c:pt>
                  <c:pt idx="4">
                    <c:v>5.6308801338060079E-2</c:v>
                  </c:pt>
                  <c:pt idx="5">
                    <c:v>3.0991879561905671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8,Sheet2!$J$8,Sheet2!$O$8,Sheet2!$T$8,Sheet2!$Y$8,Sheet2!$AD$8)</c:f>
              <c:numCache>
                <c:formatCode>General</c:formatCode>
                <c:ptCount val="6"/>
                <c:pt idx="0">
                  <c:v>7.1222343522897624</c:v>
                </c:pt>
                <c:pt idx="1">
                  <c:v>7.2114756283492101</c:v>
                </c:pt>
                <c:pt idx="2">
                  <c:v>7.7210537916590063</c:v>
                </c:pt>
                <c:pt idx="3">
                  <c:v>8.1069092422147246</c:v>
                </c:pt>
                <c:pt idx="4">
                  <c:v>8.4910843677986154</c:v>
                </c:pt>
                <c:pt idx="5">
                  <c:v>8.8356369085171735</c:v>
                </c:pt>
              </c:numCache>
            </c:numRef>
          </c:yVal>
          <c:smooth val="1"/>
        </c:ser>
        <c:ser>
          <c:idx val="1"/>
          <c:order val="1"/>
          <c:tx>
            <c:v>229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8,Sheet3!$AL$8,Sheet3!$AQ$8,Sheet3!$AV$8,Sheet3!$BA$8,Sheet3!$BF$8)</c:f>
                <c:numCache>
                  <c:formatCode>General</c:formatCode>
                  <c:ptCount val="6"/>
                  <c:pt idx="0">
                    <c:v>3.842078633420163E-2</c:v>
                  </c:pt>
                  <c:pt idx="1">
                    <c:v>9.5239675373051703E-3</c:v>
                  </c:pt>
                  <c:pt idx="2">
                    <c:v>2.6297071122549302E-2</c:v>
                  </c:pt>
                  <c:pt idx="3">
                    <c:v>3.9120377439591035E-2</c:v>
                  </c:pt>
                  <c:pt idx="4">
                    <c:v>9.3345878675835641E-3</c:v>
                  </c:pt>
                  <c:pt idx="5">
                    <c:v>6.5006147015585648E-3</c:v>
                  </c:pt>
                </c:numCache>
              </c:numRef>
            </c:plus>
            <c:minus>
              <c:numRef>
                <c:f>(Sheet3!$AG$8,Sheet3!$AL$8,Sheet3!$AQ$8,Sheet3!$AV$8,Sheet3!$BA$8,Sheet3!$BF$8)</c:f>
                <c:numCache>
                  <c:formatCode>General</c:formatCode>
                  <c:ptCount val="6"/>
                  <c:pt idx="0">
                    <c:v>3.842078633420163E-2</c:v>
                  </c:pt>
                  <c:pt idx="1">
                    <c:v>9.5239675373051703E-3</c:v>
                  </c:pt>
                  <c:pt idx="2">
                    <c:v>2.6297071122549302E-2</c:v>
                  </c:pt>
                  <c:pt idx="3">
                    <c:v>3.9120377439591035E-2</c:v>
                  </c:pt>
                  <c:pt idx="4">
                    <c:v>9.3345878675835641E-3</c:v>
                  </c:pt>
                  <c:pt idx="5">
                    <c:v>6.5006147015585648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8,Sheet3!$AK$8,Sheet3!$AP$8,Sheet3!$AU$8,Sheet3!$AZ$8,Sheet3!$BE$8)</c:f>
              <c:numCache>
                <c:formatCode>General</c:formatCode>
                <c:ptCount val="6"/>
                <c:pt idx="0">
                  <c:v>7.2438454629511826</c:v>
                </c:pt>
                <c:pt idx="1">
                  <c:v>7.3356882187927779</c:v>
                </c:pt>
                <c:pt idx="2">
                  <c:v>7.8723334470403001</c:v>
                </c:pt>
                <c:pt idx="3">
                  <c:v>7.8307394099974621</c:v>
                </c:pt>
                <c:pt idx="4">
                  <c:v>7.7744164204196045</c:v>
                </c:pt>
                <c:pt idx="5">
                  <c:v>7.691032844899279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302592"/>
        <c:axId val="73303168"/>
      </c:scatterChart>
      <c:valAx>
        <c:axId val="73302592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3303168"/>
        <c:crosses val="autoZero"/>
        <c:crossBetween val="midCat"/>
      </c:valAx>
      <c:valAx>
        <c:axId val="73303168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3302592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78053289911379"/>
          <c:y val="6.7778793218797415E-2"/>
          <c:w val="0.76364413823272093"/>
          <c:h val="0.70951371064012136"/>
        </c:manualLayout>
      </c:layout>
      <c:scatterChart>
        <c:scatterStyle val="smoothMarker"/>
        <c:varyColors val="0"/>
        <c:ser>
          <c:idx val="0"/>
          <c:order val="0"/>
          <c:tx>
            <c:v>L. lactis UC063</c:v>
          </c:tx>
          <c:spPr>
            <a:ln w="12700">
              <a:solidFill>
                <a:srgbClr val="0070C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12,Sheet2!$K$12,Sheet2!$P$12,Sheet2!$U$12,Sheet2!$Z$12,Sheet2!$AE$12)</c:f>
                <c:numCache>
                  <c:formatCode>General</c:formatCode>
                  <c:ptCount val="6"/>
                  <c:pt idx="0">
                    <c:v>0.48581046930053784</c:v>
                  </c:pt>
                  <c:pt idx="1">
                    <c:v>2.5676675814157272E-2</c:v>
                  </c:pt>
                  <c:pt idx="2">
                    <c:v>2.2277664928754791E-2</c:v>
                  </c:pt>
                  <c:pt idx="3">
                    <c:v>1.0399453889946408E-2</c:v>
                  </c:pt>
                  <c:pt idx="4">
                    <c:v>0.49927257594826085</c:v>
                  </c:pt>
                  <c:pt idx="5">
                    <c:v>4.5424852626341466E-2</c:v>
                  </c:pt>
                </c:numCache>
              </c:numRef>
            </c:plus>
            <c:minus>
              <c:numRef>
                <c:f>(Sheet2!$F$12,Sheet2!$K$12,Sheet2!$P$12,Sheet2!$U$12,Sheet2!$Z$12,Sheet2!$AE$12)</c:f>
                <c:numCache>
                  <c:formatCode>General</c:formatCode>
                  <c:ptCount val="6"/>
                  <c:pt idx="0">
                    <c:v>0.48581046930053784</c:v>
                  </c:pt>
                  <c:pt idx="1">
                    <c:v>2.5676675814157272E-2</c:v>
                  </c:pt>
                  <c:pt idx="2">
                    <c:v>2.2277664928754791E-2</c:v>
                  </c:pt>
                  <c:pt idx="3">
                    <c:v>1.0399453889946408E-2</c:v>
                  </c:pt>
                  <c:pt idx="4">
                    <c:v>0.49927257594826085</c:v>
                  </c:pt>
                  <c:pt idx="5">
                    <c:v>4.5424852626341466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12,Sheet2!$J$12,Sheet2!$O$12,Sheet2!$T$12,Sheet2!$Y$12,Sheet2!$AD$12)</c:f>
              <c:numCache>
                <c:formatCode>General</c:formatCode>
                <c:ptCount val="6"/>
                <c:pt idx="0">
                  <c:v>7.5224832871810285</c:v>
                </c:pt>
                <c:pt idx="1">
                  <c:v>7.3960318985471334</c:v>
                </c:pt>
                <c:pt idx="2">
                  <c:v>7.7871317930366537</c:v>
                </c:pt>
                <c:pt idx="3">
                  <c:v>8.1408026476673196</c:v>
                </c:pt>
                <c:pt idx="4">
                  <c:v>8.1965530767763237</c:v>
                </c:pt>
                <c:pt idx="5">
                  <c:v>8.7353422288989364</c:v>
                </c:pt>
              </c:numCache>
            </c:numRef>
          </c:yVal>
          <c:smooth val="1"/>
        </c:ser>
        <c:ser>
          <c:idx val="1"/>
          <c:order val="1"/>
          <c:tx>
            <c:v>UC063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12,Sheet3!$AL$12,Sheet3!$AQ$12,Sheet3!$AV$12,Sheet3!$BA$12,Sheet3!$BF$12)</c:f>
                <c:numCache>
                  <c:formatCode>General</c:formatCode>
                  <c:ptCount val="6"/>
                  <c:pt idx="0">
                    <c:v>0.48581046930053784</c:v>
                  </c:pt>
                  <c:pt idx="1">
                    <c:v>9.5864090669550324E-3</c:v>
                  </c:pt>
                  <c:pt idx="2">
                    <c:v>7.4239815220249472E-2</c:v>
                  </c:pt>
                  <c:pt idx="3">
                    <c:v>6.6527607085917753E-3</c:v>
                  </c:pt>
                  <c:pt idx="4">
                    <c:v>6.0412707829193765E-3</c:v>
                  </c:pt>
                  <c:pt idx="5">
                    <c:v>9.9818082596087494E-3</c:v>
                  </c:pt>
                </c:numCache>
              </c:numRef>
            </c:plus>
            <c:minus>
              <c:numRef>
                <c:f>(Sheet3!$AG$12,Sheet3!$AL$12,Sheet3!$AQ$12,Sheet3!$AV$12,Sheet3!$BA$12,Sheet3!$BF$12)</c:f>
                <c:numCache>
                  <c:formatCode>General</c:formatCode>
                  <c:ptCount val="6"/>
                  <c:pt idx="0">
                    <c:v>0.48581046930053784</c:v>
                  </c:pt>
                  <c:pt idx="1">
                    <c:v>9.5864090669550324E-3</c:v>
                  </c:pt>
                  <c:pt idx="2">
                    <c:v>7.4239815220249472E-2</c:v>
                  </c:pt>
                  <c:pt idx="3">
                    <c:v>6.6527607085917753E-3</c:v>
                  </c:pt>
                  <c:pt idx="4">
                    <c:v>6.0412707829193765E-3</c:v>
                  </c:pt>
                  <c:pt idx="5">
                    <c:v>9.9818082596087494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12,Sheet3!$AK$12,Sheet3!$AP$12,Sheet3!$AU$12,Sheet3!$AZ$12,Sheet3!$BE$12)</c:f>
              <c:numCache>
                <c:formatCode>General</c:formatCode>
                <c:ptCount val="6"/>
                <c:pt idx="0">
                  <c:v>7.5224832871810285</c:v>
                </c:pt>
                <c:pt idx="1">
                  <c:v>7.5680959404836976</c:v>
                </c:pt>
                <c:pt idx="2">
                  <c:v>7.8646327669027807</c:v>
                </c:pt>
                <c:pt idx="3">
                  <c:v>7.9119939772505781</c:v>
                </c:pt>
                <c:pt idx="4">
                  <c:v>7.7812346196526461</c:v>
                </c:pt>
                <c:pt idx="5">
                  <c:v>7.759804527804482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304896"/>
        <c:axId val="73305472"/>
      </c:scatterChart>
      <c:valAx>
        <c:axId val="73304896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3305472"/>
        <c:crosses val="autoZero"/>
        <c:crossBetween val="midCat"/>
      </c:valAx>
      <c:valAx>
        <c:axId val="73305472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3304896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52012248468942"/>
          <c:y val="8.2569930605052216E-2"/>
          <c:w val="0.76364413823272093"/>
          <c:h val="0.69472257325386655"/>
        </c:manualLayout>
      </c:layout>
      <c:scatterChart>
        <c:scatterStyle val="smoothMarker"/>
        <c:varyColors val="0"/>
        <c:ser>
          <c:idx val="0"/>
          <c:order val="0"/>
          <c:tx>
            <c:v>L. lactis SK11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14,Sheet2!$K$14,Sheet2!$P$14,Sheet2!$U$14,Sheet2!$Z$14,Sheet2!$AE$14)</c:f>
                <c:numCache>
                  <c:formatCode>General</c:formatCode>
                  <c:ptCount val="6"/>
                  <c:pt idx="0">
                    <c:v>4.2158096527958377E-2</c:v>
                  </c:pt>
                  <c:pt idx="1">
                    <c:v>2.3673808277356701E-2</c:v>
                  </c:pt>
                  <c:pt idx="2">
                    <c:v>4.2963461247549434E-2</c:v>
                  </c:pt>
                  <c:pt idx="3">
                    <c:v>4.8420180068062015E-2</c:v>
                  </c:pt>
                  <c:pt idx="4">
                    <c:v>2.0885943906871294E-2</c:v>
                  </c:pt>
                  <c:pt idx="5">
                    <c:v>2.0885943906871294E-2</c:v>
                  </c:pt>
                </c:numCache>
              </c:numRef>
            </c:plus>
            <c:minus>
              <c:numRef>
                <c:f>(Sheet2!$F$14,Sheet2!$K$14,Sheet2!$P$14,Sheet2!$U$14,Sheet2!$Z$14,Sheet2!$AE$14)</c:f>
                <c:numCache>
                  <c:formatCode>General</c:formatCode>
                  <c:ptCount val="6"/>
                  <c:pt idx="0">
                    <c:v>4.2158096527958377E-2</c:v>
                  </c:pt>
                  <c:pt idx="1">
                    <c:v>2.3673808277356701E-2</c:v>
                  </c:pt>
                  <c:pt idx="2">
                    <c:v>4.2963461247549434E-2</c:v>
                  </c:pt>
                  <c:pt idx="3">
                    <c:v>4.8420180068062015E-2</c:v>
                  </c:pt>
                  <c:pt idx="4">
                    <c:v>2.0885943906871294E-2</c:v>
                  </c:pt>
                  <c:pt idx="5">
                    <c:v>2.0885943906871294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14,Sheet2!$J$14,Sheet2!$O$14,Sheet2!$T$14,Sheet2!$Y$14,Sheet2!$AD$14)</c:f>
              <c:numCache>
                <c:formatCode>General</c:formatCode>
                <c:ptCount val="6"/>
                <c:pt idx="0">
                  <c:v>6.9028862681801657</c:v>
                </c:pt>
                <c:pt idx="1">
                  <c:v>7.112190598461642</c:v>
                </c:pt>
                <c:pt idx="2">
                  <c:v>7.5738489422975332</c:v>
                </c:pt>
                <c:pt idx="3">
                  <c:v>7.7105737639938825</c:v>
                </c:pt>
                <c:pt idx="4">
                  <c:v>8.2299471363791685</c:v>
                </c:pt>
                <c:pt idx="5">
                  <c:v>8.2299471363791685</c:v>
                </c:pt>
              </c:numCache>
            </c:numRef>
          </c:yVal>
          <c:smooth val="1"/>
        </c:ser>
        <c:ser>
          <c:idx val="1"/>
          <c:order val="1"/>
          <c:tx>
            <c:v>SK11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14,Sheet3!$AL$14,Sheet3!$AQ$14,Sheet3!$AV$14,Sheet3!$BA$14,Sheet3!$BF$14)</c:f>
                <c:numCache>
                  <c:formatCode>General</c:formatCode>
                  <c:ptCount val="6"/>
                  <c:pt idx="0">
                    <c:v>5.8852664653296555E-2</c:v>
                  </c:pt>
                  <c:pt idx="1">
                    <c:v>4.2027023734442753E-2</c:v>
                  </c:pt>
                  <c:pt idx="2">
                    <c:v>4.3260968874532089E-2</c:v>
                  </c:pt>
                  <c:pt idx="3">
                    <c:v>3.4244041108170795E-2</c:v>
                  </c:pt>
                  <c:pt idx="4">
                    <c:v>3.5554958774817742E-2</c:v>
                  </c:pt>
                  <c:pt idx="5">
                    <c:v>2.9633456371786552E-2</c:v>
                  </c:pt>
                </c:numCache>
              </c:numRef>
            </c:plus>
            <c:minus>
              <c:numRef>
                <c:f>(Sheet3!$AG$14,Sheet3!$AL$14,Sheet3!$AQ$14,Sheet3!$AV$14,Sheet3!$BA$14,Sheet3!$BF$14)</c:f>
                <c:numCache>
                  <c:formatCode>General</c:formatCode>
                  <c:ptCount val="6"/>
                  <c:pt idx="0">
                    <c:v>5.8852664653296555E-2</c:v>
                  </c:pt>
                  <c:pt idx="1">
                    <c:v>4.2027023734442753E-2</c:v>
                  </c:pt>
                  <c:pt idx="2">
                    <c:v>4.3260968874532089E-2</c:v>
                  </c:pt>
                  <c:pt idx="3">
                    <c:v>3.4244041108170795E-2</c:v>
                  </c:pt>
                  <c:pt idx="4">
                    <c:v>3.5554958774817742E-2</c:v>
                  </c:pt>
                  <c:pt idx="5">
                    <c:v>2.9633456371786552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14,Sheet3!$AK$14,Sheet3!$AP$14,Sheet3!$AU$14,Sheet3!$AZ$14,Sheet3!$BE$14)</c:f>
              <c:numCache>
                <c:formatCode>General</c:formatCode>
                <c:ptCount val="6"/>
                <c:pt idx="0">
                  <c:v>6.8068191522564376</c:v>
                </c:pt>
                <c:pt idx="1">
                  <c:v>7.0008809585473317</c:v>
                </c:pt>
                <c:pt idx="2">
                  <c:v>7.2610390458301559</c:v>
                </c:pt>
                <c:pt idx="3">
                  <c:v>6.9748321263447037</c:v>
                </c:pt>
                <c:pt idx="4">
                  <c:v>6.7388978663899186</c:v>
                </c:pt>
                <c:pt idx="5">
                  <c:v>6.839943539301210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307200"/>
        <c:axId val="73307776"/>
      </c:scatterChart>
      <c:valAx>
        <c:axId val="73307200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3307776"/>
        <c:crosses val="autoZero"/>
        <c:crossBetween val="midCat"/>
      </c:valAx>
      <c:valAx>
        <c:axId val="73307776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IE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IE" sz="8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fu/ml</a:t>
                </a:r>
                <a:endParaRPr lang="en-IE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3307200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52012248468942"/>
          <c:y val="8.1889536536199473E-2"/>
          <c:w val="0.76364413823272093"/>
          <c:h val="0.6836158834409749"/>
        </c:manualLayout>
      </c:layout>
      <c:scatterChart>
        <c:scatterStyle val="smoothMarker"/>
        <c:varyColors val="0"/>
        <c:ser>
          <c:idx val="0"/>
          <c:order val="0"/>
          <c:tx>
            <c:v>L. lactis UC109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15,Sheet2!$K$15,Sheet2!$P$15,Sheet2!$U$15,Sheet2!$Z$15,Sheet2!$AE$15)</c:f>
                <c:numCache>
                  <c:formatCode>General</c:formatCode>
                  <c:ptCount val="6"/>
                  <c:pt idx="0">
                    <c:v>5.1706795969510673E-2</c:v>
                  </c:pt>
                  <c:pt idx="1">
                    <c:v>3.9630532571862005E-2</c:v>
                  </c:pt>
                  <c:pt idx="2">
                    <c:v>5.8341069417315664E-2</c:v>
                  </c:pt>
                  <c:pt idx="3">
                    <c:v>6.0131817517024228E-3</c:v>
                  </c:pt>
                  <c:pt idx="4">
                    <c:v>3.2303148997650979E-2</c:v>
                  </c:pt>
                  <c:pt idx="5">
                    <c:v>1.9124078239140477E-2</c:v>
                  </c:pt>
                </c:numCache>
              </c:numRef>
            </c:plus>
            <c:minus>
              <c:numRef>
                <c:f>(Sheet2!$F$15,Sheet2!$K$15,Sheet2!$P$15,Sheet2!$U$15,Sheet2!$Z$15,Sheet2!$AE$15)</c:f>
                <c:numCache>
                  <c:formatCode>General</c:formatCode>
                  <c:ptCount val="6"/>
                  <c:pt idx="0">
                    <c:v>5.1706795969510673E-2</c:v>
                  </c:pt>
                  <c:pt idx="1">
                    <c:v>3.9630532571862005E-2</c:v>
                  </c:pt>
                  <c:pt idx="2">
                    <c:v>5.8341069417315664E-2</c:v>
                  </c:pt>
                  <c:pt idx="3">
                    <c:v>6.0131817517024228E-3</c:v>
                  </c:pt>
                  <c:pt idx="4">
                    <c:v>3.2303148997650979E-2</c:v>
                  </c:pt>
                  <c:pt idx="5">
                    <c:v>1.912407823914047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15,Sheet2!$J$15,Sheet2!$O$15,Sheet2!$T$15,Sheet2!$Y$15,Sheet2!$AD$15)</c:f>
              <c:numCache>
                <c:formatCode>General</c:formatCode>
                <c:ptCount val="6"/>
                <c:pt idx="0">
                  <c:v>5.9124889909621912</c:v>
                </c:pt>
                <c:pt idx="1">
                  <c:v>6.0845871432823389</c:v>
                </c:pt>
                <c:pt idx="2">
                  <c:v>6.7035467355739433</c:v>
                </c:pt>
                <c:pt idx="3">
                  <c:v>7.1721720238299609</c:v>
                </c:pt>
                <c:pt idx="4">
                  <c:v>7.3573896015262541</c:v>
                </c:pt>
                <c:pt idx="5">
                  <c:v>7.3675539692008165</c:v>
                </c:pt>
              </c:numCache>
            </c:numRef>
          </c:yVal>
          <c:smooth val="1"/>
        </c:ser>
        <c:ser>
          <c:idx val="1"/>
          <c:order val="1"/>
          <c:tx>
            <c:v>UC109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15,Sheet3!$AL$15,Sheet3!$AQ$15,Sheet3!$AV$15,Sheet3!$BA$15,Sheet3!$BF$15)</c:f>
                <c:numCache>
                  <c:formatCode>General</c:formatCode>
                  <c:ptCount val="6"/>
                  <c:pt idx="0">
                    <c:v>5.1706795969510673E-2</c:v>
                  </c:pt>
                  <c:pt idx="1">
                    <c:v>0.46616099962598129</c:v>
                  </c:pt>
                  <c:pt idx="2">
                    <c:v>1.314009327885913E-2</c:v>
                  </c:pt>
                  <c:pt idx="3">
                    <c:v>3.596244402060339E-2</c:v>
                  </c:pt>
                  <c:pt idx="4">
                    <c:v>2.8070474558280867E-2</c:v>
                  </c:pt>
                  <c:pt idx="5">
                    <c:v>1.7194072705685147E-2</c:v>
                  </c:pt>
                </c:numCache>
              </c:numRef>
            </c:plus>
            <c:minus>
              <c:numRef>
                <c:f>(Sheet3!$AG$15,Sheet3!$AL$15,Sheet3!$AQ$15,Sheet3!$AV$15,Sheet3!$BA$15,Sheet3!$BF$15)</c:f>
                <c:numCache>
                  <c:formatCode>General</c:formatCode>
                  <c:ptCount val="6"/>
                  <c:pt idx="0">
                    <c:v>5.1706795969510673E-2</c:v>
                  </c:pt>
                  <c:pt idx="1">
                    <c:v>0.46616099962598129</c:v>
                  </c:pt>
                  <c:pt idx="2">
                    <c:v>1.314009327885913E-2</c:v>
                  </c:pt>
                  <c:pt idx="3">
                    <c:v>3.596244402060339E-2</c:v>
                  </c:pt>
                  <c:pt idx="4">
                    <c:v>2.8070474558280867E-2</c:v>
                  </c:pt>
                  <c:pt idx="5">
                    <c:v>1.719407270568514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15,Sheet3!$AK$15,Sheet3!$AP$15,Sheet3!$AU$15,Sheet3!$AZ$15,Sheet3!$BE$15)</c:f>
              <c:numCache>
                <c:formatCode>General</c:formatCode>
                <c:ptCount val="6"/>
                <c:pt idx="0">
                  <c:v>5.9124889909621912</c:v>
                </c:pt>
                <c:pt idx="1">
                  <c:v>6.2377741683290084</c:v>
                </c:pt>
                <c:pt idx="2">
                  <c:v>6.73219504348799</c:v>
                </c:pt>
                <c:pt idx="3">
                  <c:v>6.8735452249317381</c:v>
                </c:pt>
                <c:pt idx="4">
                  <c:v>6.6422256365992327</c:v>
                </c:pt>
                <c:pt idx="5">
                  <c:v>6.582482892873996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309504"/>
        <c:axId val="74063872"/>
      </c:scatterChart>
      <c:valAx>
        <c:axId val="73309504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4063872"/>
        <c:crosses val="autoZero"/>
        <c:crossBetween val="midCat"/>
      </c:valAx>
      <c:valAx>
        <c:axId val="74063872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Log</a:t>
                </a:r>
                <a:r>
                  <a:rPr lang="en-IE" sz="800" baseline="0"/>
                  <a:t> cfu/ml</a:t>
                </a:r>
                <a:endParaRPr lang="en-IE" sz="80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3309504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52012248468942"/>
          <c:y val="8.18895365361995E-2"/>
          <c:w val="0.76364413823272093"/>
          <c:h val="0.6836158834409749"/>
        </c:manualLayout>
      </c:layout>
      <c:scatterChart>
        <c:scatterStyle val="smoothMarker"/>
        <c:varyColors val="0"/>
        <c:ser>
          <c:idx val="0"/>
          <c:order val="0"/>
          <c:tx>
            <c:v>L. lactis 158</c:v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16,Sheet2!$K$16,Sheet2!$P$16,Sheet2!$U$16,Sheet2!$Z$16,Sheet2!$AE$16)</c:f>
                <c:numCache>
                  <c:formatCode>General</c:formatCode>
                  <c:ptCount val="6"/>
                  <c:pt idx="0">
                    <c:v>3.9630532571862005E-2</c:v>
                  </c:pt>
                  <c:pt idx="1">
                    <c:v>2.8379467526103978E-2</c:v>
                  </c:pt>
                  <c:pt idx="2">
                    <c:v>0.10441427575171967</c:v>
                  </c:pt>
                  <c:pt idx="3">
                    <c:v>9.8720288614426409E-3</c:v>
                  </c:pt>
                  <c:pt idx="4">
                    <c:v>9.5220358365869836E-3</c:v>
                  </c:pt>
                  <c:pt idx="5">
                    <c:v>5.6790934099827044E-2</c:v>
                  </c:pt>
                </c:numCache>
              </c:numRef>
            </c:plus>
            <c:minus>
              <c:numRef>
                <c:f>(Sheet2!$F$16,Sheet2!$K$16,Sheet2!$P$16,Sheet2!$U$16,Sheet2!$Z$16,Sheet2!$AE$16)</c:f>
                <c:numCache>
                  <c:formatCode>General</c:formatCode>
                  <c:ptCount val="6"/>
                  <c:pt idx="0">
                    <c:v>3.9630532571862005E-2</c:v>
                  </c:pt>
                  <c:pt idx="1">
                    <c:v>2.8379467526103978E-2</c:v>
                  </c:pt>
                  <c:pt idx="2">
                    <c:v>0.10441427575171967</c:v>
                  </c:pt>
                  <c:pt idx="3">
                    <c:v>9.8720288614426409E-3</c:v>
                  </c:pt>
                  <c:pt idx="4">
                    <c:v>9.5220358365869836E-3</c:v>
                  </c:pt>
                  <c:pt idx="5">
                    <c:v>5.6790934099827044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AG$2:$AG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2!$E$16,Sheet2!$J$16,Sheet2!$O$16,Sheet2!$T$16,Sheet2!$Y$16,Sheet2!$AD$16)</c:f>
              <c:numCache>
                <c:formatCode>General</c:formatCode>
                <c:ptCount val="6"/>
                <c:pt idx="0">
                  <c:v>7.0845871432823389</c:v>
                </c:pt>
                <c:pt idx="1">
                  <c:v>7.1389467123579236</c:v>
                </c:pt>
                <c:pt idx="2">
                  <c:v>7.1230719524700481</c:v>
                </c:pt>
                <c:pt idx="3">
                  <c:v>7.5593956623363612</c:v>
                </c:pt>
                <c:pt idx="4">
                  <c:v>8.1730819004882829</c:v>
                </c:pt>
                <c:pt idx="5">
                  <c:v>8.2003242985622489</c:v>
                </c:pt>
              </c:numCache>
            </c:numRef>
          </c:yVal>
          <c:smooth val="1"/>
        </c:ser>
        <c:ser>
          <c:idx val="1"/>
          <c:order val="1"/>
          <c:tx>
            <c:v>158P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Sheet3!$AG$16,Sheet3!$AL$16,Sheet3!$AQ$16,Sheet3!$AV$16,Sheet3!$BA$16,Sheet3!$BF$16)</c:f>
                <c:numCache>
                  <c:formatCode>General</c:formatCode>
                  <c:ptCount val="6"/>
                  <c:pt idx="0">
                    <c:v>3.1275583891019962E-2</c:v>
                  </c:pt>
                  <c:pt idx="1">
                    <c:v>6.7541201116542673E-2</c:v>
                  </c:pt>
                  <c:pt idx="2">
                    <c:v>6.5905657685773672E-3</c:v>
                  </c:pt>
                  <c:pt idx="3">
                    <c:v>4.544160238166825E-2</c:v>
                  </c:pt>
                  <c:pt idx="4">
                    <c:v>3.8486237292387815E-2</c:v>
                  </c:pt>
                  <c:pt idx="5">
                    <c:v>4.5715822807992232E-2</c:v>
                  </c:pt>
                </c:numCache>
              </c:numRef>
            </c:plus>
            <c:minus>
              <c:numRef>
                <c:f>(Sheet3!$AG$16,Sheet3!$AL$16,Sheet3!$AQ$16,Sheet3!$AV$16,Sheet3!$BA$16,Sheet3!$BF$16)</c:f>
                <c:numCache>
                  <c:formatCode>General</c:formatCode>
                  <c:ptCount val="6"/>
                  <c:pt idx="0">
                    <c:v>3.1275583891019962E-2</c:v>
                  </c:pt>
                  <c:pt idx="1">
                    <c:v>6.7541201116542673E-2</c:v>
                  </c:pt>
                  <c:pt idx="2">
                    <c:v>6.5905657685773672E-3</c:v>
                  </c:pt>
                  <c:pt idx="3">
                    <c:v>4.544160238166825E-2</c:v>
                  </c:pt>
                  <c:pt idx="4">
                    <c:v>3.8486237292387815E-2</c:v>
                  </c:pt>
                  <c:pt idx="5">
                    <c:v>4.5715822807992232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Z$2:$Z$7</c:f>
              <c:numCache>
                <c:formatCode>General</c:formatCode>
                <c:ptCount val="6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80</c:v>
                </c:pt>
                <c:pt idx="4">
                  <c:v>240</c:v>
                </c:pt>
                <c:pt idx="5">
                  <c:v>300</c:v>
                </c:pt>
              </c:numCache>
            </c:numRef>
          </c:xVal>
          <c:yVal>
            <c:numRef>
              <c:f>(Sheet3!$AF$16,Sheet3!$AK$16,Sheet3!$AP$16,Sheet3!$AU$16,Sheet3!$AZ$16,Sheet3!$BE$16)</c:f>
              <c:numCache>
                <c:formatCode>General</c:formatCode>
                <c:ptCount val="6"/>
                <c:pt idx="0">
                  <c:v>7.0117271663256426</c:v>
                </c:pt>
                <c:pt idx="1">
                  <c:v>7.4151708892713835</c:v>
                </c:pt>
                <c:pt idx="2">
                  <c:v>8.1324232119128474</c:v>
                </c:pt>
                <c:pt idx="3">
                  <c:v>7.4549503506692316</c:v>
                </c:pt>
                <c:pt idx="4">
                  <c:v>7.1987923813325336</c:v>
                </c:pt>
                <c:pt idx="5">
                  <c:v>7.216867593950957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065600"/>
        <c:axId val="74066176"/>
      </c:scatterChart>
      <c:valAx>
        <c:axId val="74065600"/>
        <c:scaling>
          <c:orientation val="minMax"/>
          <c:max val="32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Time (mins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74066176"/>
        <c:crosses val="autoZero"/>
        <c:crossBetween val="midCat"/>
      </c:valAx>
      <c:valAx>
        <c:axId val="74066176"/>
        <c:scaling>
          <c:orientation val="minMax"/>
          <c:max val="9.5"/>
          <c:min val="5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800"/>
                </a:pPr>
                <a:r>
                  <a:rPr lang="en-IE" sz="800"/>
                  <a:t>Log</a:t>
                </a:r>
                <a:r>
                  <a:rPr lang="en-IE" sz="800" baseline="0"/>
                  <a:t> cfu/ml</a:t>
                </a:r>
                <a:endParaRPr lang="en-IE" sz="80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4065600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52758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58645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56266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3690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48648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74537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92928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33663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5211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65772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62170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53DDB-DE26-4849-91D4-4939D5D035C2}" type="datetimeFigureOut">
              <a:rPr lang="en-IE" smtClean="0"/>
              <a:t>07/09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CADCE-9A6E-4DD1-98EF-13F0956B4C1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10556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4528026"/>
              </p:ext>
            </p:extLst>
          </p:nvPr>
        </p:nvGraphicFramePr>
        <p:xfrm>
          <a:off x="78935" y="784961"/>
          <a:ext cx="2176473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9811120"/>
              </p:ext>
            </p:extLst>
          </p:nvPr>
        </p:nvGraphicFramePr>
        <p:xfrm>
          <a:off x="2366876" y="784961"/>
          <a:ext cx="2174816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3217080"/>
              </p:ext>
            </p:extLst>
          </p:nvPr>
        </p:nvGraphicFramePr>
        <p:xfrm>
          <a:off x="4653160" y="784961"/>
          <a:ext cx="2174816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7101290"/>
              </p:ext>
            </p:extLst>
          </p:nvPr>
        </p:nvGraphicFramePr>
        <p:xfrm>
          <a:off x="78935" y="2177198"/>
          <a:ext cx="2176473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5716202"/>
              </p:ext>
            </p:extLst>
          </p:nvPr>
        </p:nvGraphicFramePr>
        <p:xfrm>
          <a:off x="2366876" y="2177198"/>
          <a:ext cx="2190655" cy="1138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6486107"/>
              </p:ext>
            </p:extLst>
          </p:nvPr>
        </p:nvGraphicFramePr>
        <p:xfrm>
          <a:off x="4653160" y="2177198"/>
          <a:ext cx="2176472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7530111"/>
              </p:ext>
            </p:extLst>
          </p:nvPr>
        </p:nvGraphicFramePr>
        <p:xfrm>
          <a:off x="78935" y="3569435"/>
          <a:ext cx="2176961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1693294"/>
              </p:ext>
            </p:extLst>
          </p:nvPr>
        </p:nvGraphicFramePr>
        <p:xfrm>
          <a:off x="2366876" y="3569435"/>
          <a:ext cx="2176472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8491680"/>
              </p:ext>
            </p:extLst>
          </p:nvPr>
        </p:nvGraphicFramePr>
        <p:xfrm>
          <a:off x="4653160" y="3569435"/>
          <a:ext cx="2176472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8049767"/>
              </p:ext>
            </p:extLst>
          </p:nvPr>
        </p:nvGraphicFramePr>
        <p:xfrm>
          <a:off x="78935" y="4961673"/>
          <a:ext cx="2176473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3682865"/>
              </p:ext>
            </p:extLst>
          </p:nvPr>
        </p:nvGraphicFramePr>
        <p:xfrm>
          <a:off x="2366876" y="4961673"/>
          <a:ext cx="2176472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2974148"/>
              </p:ext>
            </p:extLst>
          </p:nvPr>
        </p:nvGraphicFramePr>
        <p:xfrm>
          <a:off x="4653160" y="4961673"/>
          <a:ext cx="2176472" cy="1143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116632" y="48850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A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348880" y="48850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B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653136" y="48850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C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6632" y="193969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D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348880" y="193969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E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53136" y="193969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F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6632" y="329681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G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48880" y="329681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H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653136" y="329681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I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6632" y="474800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J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348880" y="474800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K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653136" y="474800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L]</a:t>
            </a:r>
            <a:endParaRPr lang="en-I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839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vonne</dc:creator>
  <cp:lastModifiedBy>Yvonne</cp:lastModifiedBy>
  <cp:revision>3</cp:revision>
  <cp:lastPrinted>2016-08-19T08:27:15Z</cp:lastPrinted>
  <dcterms:created xsi:type="dcterms:W3CDTF">2016-08-06T12:38:29Z</dcterms:created>
  <dcterms:modified xsi:type="dcterms:W3CDTF">2016-09-07T09:31:25Z</dcterms:modified>
</cp:coreProperties>
</file>